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4"/>
  </p:sldMasterIdLst>
  <p:notesMasterIdLst>
    <p:notesMasterId r:id="rId6"/>
  </p:notesMasterIdLst>
  <p:sldIdLst>
    <p:sldId id="26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1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9294B782-A428-4EB6-96EF-47F8514C56F3}"/>
    <pc:docChg chg="delSld modSld">
      <pc:chgData name="Anca Pordea (staff)" userId="04217c9e-4602-4538-8d25-5638668eb9f5" providerId="ADAL" clId="{9294B782-A428-4EB6-96EF-47F8514C56F3}" dt="2023-12-19T19:15:32.680" v="19" actId="1036"/>
      <pc:docMkLst>
        <pc:docMk/>
      </pc:docMkLst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773720066" sldId="256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406690983" sldId="257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309942647" sldId="25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56002129" sldId="262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051766301" sldId="263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729401590" sldId="264"/>
        </pc:sldMkLst>
      </pc:sldChg>
      <pc:sldChg chg="del">
        <pc:chgData name="Anca Pordea (staff)" userId="04217c9e-4602-4538-8d25-5638668eb9f5" providerId="ADAL" clId="{9294B782-A428-4EB6-96EF-47F8514C56F3}" dt="2023-12-18T19:35:47.031" v="1" actId="47"/>
        <pc:sldMkLst>
          <pc:docMk/>
          <pc:sldMk cId="1128189669" sldId="265"/>
        </pc:sldMkLst>
      </pc:sldChg>
      <pc:sldChg chg="del">
        <pc:chgData name="Anca Pordea (staff)" userId="04217c9e-4602-4538-8d25-5638668eb9f5" providerId="ADAL" clId="{9294B782-A428-4EB6-96EF-47F8514C56F3}" dt="2023-12-18T19:35:47.031" v="1" actId="47"/>
        <pc:sldMkLst>
          <pc:docMk/>
          <pc:sldMk cId="3808561837" sldId="266"/>
        </pc:sldMkLst>
      </pc:sldChg>
      <pc:sldChg chg="addSp modSp mod">
        <pc:chgData name="Anca Pordea (staff)" userId="04217c9e-4602-4538-8d25-5638668eb9f5" providerId="ADAL" clId="{9294B782-A428-4EB6-96EF-47F8514C56F3}" dt="2023-12-19T19:15:32.680" v="19" actId="1036"/>
        <pc:sldMkLst>
          <pc:docMk/>
          <pc:sldMk cId="3005349361" sldId="267"/>
        </pc:sldMkLst>
        <pc:spChg chg="add mod">
          <ac:chgData name="Anca Pordea (staff)" userId="04217c9e-4602-4538-8d25-5638668eb9f5" providerId="ADAL" clId="{9294B782-A428-4EB6-96EF-47F8514C56F3}" dt="2023-12-19T19:15:27.131" v="7" actId="14100"/>
          <ac:spMkLst>
            <pc:docMk/>
            <pc:sldMk cId="3005349361" sldId="267"/>
            <ac:spMk id="3" creationId="{5FB57B53-30F1-25F4-0707-DF7A85F3357E}"/>
          </ac:spMkLst>
        </pc:spChg>
        <pc:graphicFrameChg chg="mod">
          <ac:chgData name="Anca Pordea (staff)" userId="04217c9e-4602-4538-8d25-5638668eb9f5" providerId="ADAL" clId="{9294B782-A428-4EB6-96EF-47F8514C56F3}" dt="2023-12-19T19:15:32.680" v="19" actId="1036"/>
          <ac:graphicFrameMkLst>
            <pc:docMk/>
            <pc:sldMk cId="3005349361" sldId="267"/>
            <ac:graphicFrameMk id="4" creationId="{97B59DE7-5EF2-DE70-60D3-4C3B83F591F7}"/>
          </ac:graphicFrameMkLst>
        </pc:graphicFrameChg>
      </pc:sldChg>
      <pc:sldChg chg="del">
        <pc:chgData name="Anca Pordea (staff)" userId="04217c9e-4602-4538-8d25-5638668eb9f5" providerId="ADAL" clId="{9294B782-A428-4EB6-96EF-47F8514C56F3}" dt="2023-12-18T19:36:18.063" v="2" actId="47"/>
        <pc:sldMkLst>
          <pc:docMk/>
          <pc:sldMk cId="290462980" sldId="26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479637886" sldId="271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232706692" sldId="277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441496266" sldId="27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672111689" sldId="279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141721781" sldId="280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41255541" sldId="281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272614583" sldId="285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751480510" sldId="28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59477596" sldId="289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090511444" sldId="290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804230355" sldId="293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079981970" sldId="294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567409985" sldId="295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446155509" sldId="297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702511720" sldId="29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4077862176" sldId="299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4281819590" sldId="301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532461093" sldId="302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825408573" sldId="305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567219672" sldId="306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023848852" sldId="30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92132675" sldId="309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165866896" sldId="310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892218898" sldId="311"/>
        </pc:sldMkLst>
      </pc:sldChg>
      <pc:sldChg chg="del">
        <pc:chgData name="Anca Pordea (staff)" userId="04217c9e-4602-4538-8d25-5638668eb9f5" providerId="ADAL" clId="{9294B782-A428-4EB6-96EF-47F8514C56F3}" dt="2023-12-18T19:35:47.031" v="1" actId="47"/>
        <pc:sldMkLst>
          <pc:docMk/>
          <pc:sldMk cId="3710938837" sldId="312"/>
        </pc:sldMkLst>
      </pc:sldChg>
      <pc:sldChg chg="del">
        <pc:chgData name="Anca Pordea (staff)" userId="04217c9e-4602-4538-8d25-5638668eb9f5" providerId="ADAL" clId="{9294B782-A428-4EB6-96EF-47F8514C56F3}" dt="2023-12-18T19:35:47.031" v="1" actId="47"/>
        <pc:sldMkLst>
          <pc:docMk/>
          <pc:sldMk cId="3756588774" sldId="314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331867037" sldId="315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351316601" sldId="316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026450018" sldId="317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1156295227" sldId="318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43933656" sldId="319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2633288119" sldId="320"/>
        </pc:sldMkLst>
      </pc:sldChg>
      <pc:sldChg chg="del">
        <pc:chgData name="Anca Pordea (staff)" userId="04217c9e-4602-4538-8d25-5638668eb9f5" providerId="ADAL" clId="{9294B782-A428-4EB6-96EF-47F8514C56F3}" dt="2023-12-18T19:35:41.148" v="0" actId="47"/>
        <pc:sldMkLst>
          <pc:docMk/>
          <pc:sldMk cId="95252591" sldId="32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6 Table. Frequency of contacts between the substrate and LcpK30 calculated during 100 ns MD simulations of 10 docking poses obtained from </a:t>
            </a:r>
            <a:r>
              <a:rPr lang="en-US" b="1" dirty="0" err="1"/>
              <a:t>ChemPLP</a:t>
            </a:r>
            <a:r>
              <a:rPr lang="en-US" b="1" dirty="0"/>
              <a:t> fitness function</a:t>
            </a:r>
            <a:r>
              <a:rPr lang="en-US" dirty="0"/>
              <a:t>. Docking solutions were initially ranked based on the fitness score from highest to lowest. A cut-off of 5 Å was used and only contacts with total fraction more than 4.5 % are listed. Ext = extended conformation; Fold = folded conformation</a:t>
            </a:r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58824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7B59DE7-5EF2-DE70-60D3-4C3B83F591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5167707"/>
              </p:ext>
            </p:extLst>
          </p:nvPr>
        </p:nvGraphicFramePr>
        <p:xfrm>
          <a:off x="2597634" y="679653"/>
          <a:ext cx="6368717" cy="60501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3397">
                  <a:extLst>
                    <a:ext uri="{9D8B030D-6E8A-4147-A177-3AD203B41FA5}">
                      <a16:colId xmlns:a16="http://schemas.microsoft.com/office/drawing/2014/main" val="1322113572"/>
                    </a:ext>
                  </a:extLst>
                </a:gridCol>
                <a:gridCol w="425997">
                  <a:extLst>
                    <a:ext uri="{9D8B030D-6E8A-4147-A177-3AD203B41FA5}">
                      <a16:colId xmlns:a16="http://schemas.microsoft.com/office/drawing/2014/main" val="1560688096"/>
                    </a:ext>
                  </a:extLst>
                </a:gridCol>
                <a:gridCol w="425997">
                  <a:extLst>
                    <a:ext uri="{9D8B030D-6E8A-4147-A177-3AD203B41FA5}">
                      <a16:colId xmlns:a16="http://schemas.microsoft.com/office/drawing/2014/main" val="3765002179"/>
                    </a:ext>
                  </a:extLst>
                </a:gridCol>
                <a:gridCol w="575222">
                  <a:extLst>
                    <a:ext uri="{9D8B030D-6E8A-4147-A177-3AD203B41FA5}">
                      <a16:colId xmlns:a16="http://schemas.microsoft.com/office/drawing/2014/main" val="3823683571"/>
                    </a:ext>
                  </a:extLst>
                </a:gridCol>
                <a:gridCol w="425997">
                  <a:extLst>
                    <a:ext uri="{9D8B030D-6E8A-4147-A177-3AD203B41FA5}">
                      <a16:colId xmlns:a16="http://schemas.microsoft.com/office/drawing/2014/main" val="746055763"/>
                    </a:ext>
                  </a:extLst>
                </a:gridCol>
                <a:gridCol w="575222">
                  <a:extLst>
                    <a:ext uri="{9D8B030D-6E8A-4147-A177-3AD203B41FA5}">
                      <a16:colId xmlns:a16="http://schemas.microsoft.com/office/drawing/2014/main" val="2449615021"/>
                    </a:ext>
                  </a:extLst>
                </a:gridCol>
                <a:gridCol w="575222">
                  <a:extLst>
                    <a:ext uri="{9D8B030D-6E8A-4147-A177-3AD203B41FA5}">
                      <a16:colId xmlns:a16="http://schemas.microsoft.com/office/drawing/2014/main" val="4080783323"/>
                    </a:ext>
                  </a:extLst>
                </a:gridCol>
                <a:gridCol w="575222">
                  <a:extLst>
                    <a:ext uri="{9D8B030D-6E8A-4147-A177-3AD203B41FA5}">
                      <a16:colId xmlns:a16="http://schemas.microsoft.com/office/drawing/2014/main" val="1848156031"/>
                    </a:ext>
                  </a:extLst>
                </a:gridCol>
                <a:gridCol w="575222">
                  <a:extLst>
                    <a:ext uri="{9D8B030D-6E8A-4147-A177-3AD203B41FA5}">
                      <a16:colId xmlns:a16="http://schemas.microsoft.com/office/drawing/2014/main" val="1867436110"/>
                    </a:ext>
                  </a:extLst>
                </a:gridCol>
                <a:gridCol w="425997">
                  <a:extLst>
                    <a:ext uri="{9D8B030D-6E8A-4147-A177-3AD203B41FA5}">
                      <a16:colId xmlns:a16="http://schemas.microsoft.com/office/drawing/2014/main" val="2588672786"/>
                    </a:ext>
                  </a:extLst>
                </a:gridCol>
                <a:gridCol w="575222">
                  <a:extLst>
                    <a:ext uri="{9D8B030D-6E8A-4147-A177-3AD203B41FA5}">
                      <a16:colId xmlns:a16="http://schemas.microsoft.com/office/drawing/2014/main" val="2976878693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Rank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2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6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7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8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10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527727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Ligand conformation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Fol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Fol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Exten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Fol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Exten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Exten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Exten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Exten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Fol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Extend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843378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Residue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otal fraction (%)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418019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yr13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9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760930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13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8.4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3.4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6.0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8.5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5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3262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y13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805565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14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0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4.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4.4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810515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145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548442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u14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3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764267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al15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4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4564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la15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8.2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7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787204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p163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6.1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4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4.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64546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g16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14.1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0.6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5.6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029621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ys167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9.8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3.6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1.6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9.4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6.3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1.1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6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5.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32.0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5.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353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16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8.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1.0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7.6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9.6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9.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9.1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6.3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774256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la16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230792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g170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2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6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4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545364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eu171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8.0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9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3.8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6.2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2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6.0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7.2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0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694457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y17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5.0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3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855847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p17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0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5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9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97348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175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97334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186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789374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18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0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0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373273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r230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9.0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9.9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0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213349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p231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681630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233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8.7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1.4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4215505"/>
                  </a:ext>
                </a:extLst>
              </a:tr>
              <a:tr h="179163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eu234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8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8.6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3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28665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rp261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2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660426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u39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429538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ly393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7.2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623624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396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6.7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7.6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8.2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8.8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4.8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420334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le398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5.3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893430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p399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484923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em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6.37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34.21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39.61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5.29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40.16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46.25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8.52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46.43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26.88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37.27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203142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MY" sz="1100" dirty="0"/>
                        <a:t>O</a:t>
                      </a:r>
                      <a:r>
                        <a:rPr lang="en-MY" sz="1100" baseline="-25000" dirty="0"/>
                        <a:t>2</a:t>
                      </a: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8.1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5.69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13.53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9.17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>
                          <a:effectLst/>
                          <a:latin typeface="+mn-lt"/>
                        </a:rPr>
                        <a:t>-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14.58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9.82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036" marR="5036" marT="503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66862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FB57B53-30F1-25F4-0707-DF7A85F3357E}"/>
              </a:ext>
            </a:extLst>
          </p:cNvPr>
          <p:cNvSpPr txBox="1"/>
          <p:nvPr/>
        </p:nvSpPr>
        <p:spPr>
          <a:xfrm>
            <a:off x="236053" y="0"/>
            <a:ext cx="11839989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6 Table. Frequency of contacts between the substrate and LcpK30 calculated during 100 ns MD simulations of 10 docking poses obtained from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hemPLP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fitness func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Docking solutions were initially ranked based on the fitness score from highest to lowest. A cut-off of 5 Å was used and only contacts with total fraction more than 4.5 % are listed. Ext = extended conformation; Fold = folded conformation</a:t>
            </a:r>
            <a:endParaRPr lang="en-MY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5349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Props1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36657D4-EBCE-4BEE-8B50-6ABE2577DC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9F79417-562A-4DE7-A712-D28018C4F2AC}">
  <ds:schemaRefs>
    <ds:schemaRef ds:uri="http://schemas.microsoft.com/office/2006/documentManagement/types"/>
    <ds:schemaRef ds:uri="http://schemas.microsoft.com/office/2006/metadata/properties"/>
    <ds:schemaRef ds:uri="http://purl.org/dc/elements/1.1/"/>
    <ds:schemaRef ds:uri="http://www.w3.org/XML/1998/namespace"/>
    <ds:schemaRef ds:uri="http://schemas.openxmlformats.org/package/2006/metadata/core-properties"/>
    <ds:schemaRef ds:uri="http://schemas.microsoft.com/office/infopath/2007/PartnerControls"/>
    <ds:schemaRef ds:uri="786e620f-b1da-4f59-878c-ef7546d25bf1"/>
    <ds:schemaRef ds:uri="0c1e910d-4918-42f1-af2c-ed1101d63abc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18</TotalTime>
  <Words>522</Words>
  <Application>Microsoft Office PowerPoint</Application>
  <PresentationFormat>Widescreen</PresentationFormat>
  <Paragraphs>37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5</cp:revision>
  <dcterms:created xsi:type="dcterms:W3CDTF">2022-09-23T18:06:25Z</dcterms:created>
  <dcterms:modified xsi:type="dcterms:W3CDTF">2023-12-19T19:15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